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2268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793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038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369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803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60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34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943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732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81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43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404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3361F-B038-4899-AC2A-8F002E502A04}" type="datetimeFigureOut">
              <a:rPr lang="en-US" smtClean="0"/>
              <a:t>15-Jul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1FF8-8C14-48FB-8A85-444D1FC8FE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657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emf"/><Relationship Id="rId7" Type="http://schemas.openxmlformats.org/officeDocument/2006/relationships/image" Target="../media/image5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12" Type="http://schemas.microsoft.com/office/2007/relationships/hdphoto" Target="../media/hdphoto6.wdp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1.png"/><Relationship Id="rId5" Type="http://schemas.openxmlformats.org/officeDocument/2006/relationships/image" Target="../media/image3.png"/><Relationship Id="rId15" Type="http://schemas.openxmlformats.org/officeDocument/2006/relationships/image" Target="../media/image13.emf"/><Relationship Id="rId10" Type="http://schemas.microsoft.com/office/2007/relationships/hdphoto" Target="../media/hdphoto5.wdp"/><Relationship Id="rId4" Type="http://schemas.microsoft.com/office/2007/relationships/hdphoto" Target="../media/hdphoto3.wdp"/><Relationship Id="rId9" Type="http://schemas.openxmlformats.org/officeDocument/2006/relationships/image" Target="../media/image10.png"/><Relationship Id="rId14" Type="http://schemas.microsoft.com/office/2007/relationships/hdphoto" Target="../media/hdphoto7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18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895" y="4986908"/>
            <a:ext cx="5942013" cy="4849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5" name="Picture 18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908" y="798555"/>
            <a:ext cx="1976437" cy="3284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128464" y="159023"/>
            <a:ext cx="6612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+mj-lt"/>
              </a:rPr>
              <a:t>Supplementary figure 1</a:t>
            </a:r>
          </a:p>
        </p:txBody>
      </p:sp>
      <p:sp>
        <p:nvSpPr>
          <p:cNvPr id="5" name="Rectangle 4"/>
          <p:cNvSpPr/>
          <p:nvPr/>
        </p:nvSpPr>
        <p:spPr>
          <a:xfrm>
            <a:off x="1720416" y="416496"/>
            <a:ext cx="3429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ctr"/>
            <a:r>
              <a:rPr lang="en-US" sz="1400" u="sng" dirty="0"/>
              <a:t>Longevity of antibodies in mothers</a:t>
            </a:r>
            <a:endParaRPr lang="en-US" sz="1400" u="sng" dirty="0">
              <a:cs typeface="Times New Roman" panose="02020603050405020304" pitchFamily="18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8760" y="632520"/>
            <a:ext cx="579837" cy="301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260648" y="1118094"/>
            <a:ext cx="495833" cy="2137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Inflexal</a:t>
            </a:r>
            <a:endParaRPr lang="en-US" sz="700" dirty="0"/>
          </a:p>
        </p:txBody>
      </p:sp>
      <p:pic>
        <p:nvPicPr>
          <p:cNvPr id="14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339668" y="1254404"/>
            <a:ext cx="247012" cy="264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60648" y="2104527"/>
            <a:ext cx="495833" cy="2137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/>
              <a:t>Inflexal</a:t>
            </a:r>
            <a:endParaRPr lang="en-US" sz="700" dirty="0"/>
          </a:p>
        </p:txBody>
      </p:sp>
      <p:pic>
        <p:nvPicPr>
          <p:cNvPr id="16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358268" y="2240838"/>
            <a:ext cx="247012" cy="264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452753" y="2240838"/>
            <a:ext cx="247012" cy="264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8" name="Straight Connector 17"/>
          <p:cNvCxnSpPr/>
          <p:nvPr/>
        </p:nvCxnSpPr>
        <p:spPr>
          <a:xfrm flipV="1">
            <a:off x="1627301" y="3082823"/>
            <a:ext cx="3952" cy="806993"/>
          </a:xfrm>
          <a:prstGeom prst="line">
            <a:avLst/>
          </a:prstGeom>
          <a:ln w="12700">
            <a:solidFill>
              <a:schemeClr val="bg1">
                <a:lumMod val="65000"/>
              </a:schemeClr>
            </a:solidFill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V="1">
            <a:off x="1632805" y="1957728"/>
            <a:ext cx="3952" cy="806993"/>
          </a:xfrm>
          <a:prstGeom prst="line">
            <a:avLst/>
          </a:prstGeom>
          <a:ln w="12700">
            <a:solidFill>
              <a:schemeClr val="bg1">
                <a:lumMod val="65000"/>
              </a:schemeClr>
            </a:solidFill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04640" y="3457308"/>
            <a:ext cx="354268" cy="2137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smtClean="0"/>
              <a:t>PBS</a:t>
            </a:r>
            <a:endParaRPr lang="en-US" sz="700" dirty="0"/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1627517" y="1023973"/>
            <a:ext cx="3952" cy="724801"/>
          </a:xfrm>
          <a:prstGeom prst="line">
            <a:avLst/>
          </a:prstGeom>
          <a:ln w="12700">
            <a:solidFill>
              <a:schemeClr val="bg1">
                <a:lumMod val="65000"/>
              </a:schemeClr>
            </a:solidFill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2643951" y="1998057"/>
            <a:ext cx="395340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vel and duration of detectable maternal antibodies; ELISA titers against homologous H1 A/California/07/09 in dams. Pups were weaned at age 3 weeks. Antibodies are present longer and at higher titers when mice received a prime / boost immunization. </a:t>
            </a:r>
          </a:p>
        </p:txBody>
      </p:sp>
      <p:sp>
        <p:nvSpPr>
          <p:cNvPr id="24" name="Rectangle 23"/>
          <p:cNvSpPr/>
          <p:nvPr/>
        </p:nvSpPr>
        <p:spPr>
          <a:xfrm>
            <a:off x="128464" y="4230922"/>
            <a:ext cx="6612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+mj-lt"/>
              </a:rPr>
              <a:t>Supplementary figure 2</a:t>
            </a:r>
          </a:p>
        </p:txBody>
      </p:sp>
      <p:sp>
        <p:nvSpPr>
          <p:cNvPr id="25" name="Subtitle 2"/>
          <p:cNvSpPr txBox="1">
            <a:spLocks/>
          </p:cNvSpPr>
          <p:nvPr/>
        </p:nvSpPr>
        <p:spPr>
          <a:xfrm>
            <a:off x="128465" y="7199671"/>
            <a:ext cx="6468888" cy="142573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body </a:t>
            </a:r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onses to vaccination in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nant and non-pregnant females; ELISA </a:t>
            </a:r>
            <a:r>
              <a:rPr 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ters against homologous H1 A/California/07/09 in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nant females and non-pregnant controls. Serum samples were taken 3 weeks after delivery and samples of females which did not get pregnant were pooled in the experiment where mice were immunized twice. *p&lt;0.05 </a:t>
            </a:r>
            <a:endParaRPr 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0643" y="6650725"/>
            <a:ext cx="722339" cy="1820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Immunization: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242961" y="6650725"/>
            <a:ext cx="554476" cy="182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2058300" y="6650724"/>
            <a:ext cx="1053506" cy="182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1x Inflexal</a:t>
            </a:r>
            <a:endParaRPr lang="en-US" sz="10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1076617" y="6650724"/>
            <a:ext cx="887064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2138409" y="6650725"/>
            <a:ext cx="887064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980463" y="6843723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yes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1517336" y="6843723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no</a:t>
            </a:r>
            <a:endParaRPr lang="en-US" sz="1000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1073804" y="6855528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1582102" y="6855529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446979" y="6853978"/>
            <a:ext cx="533484" cy="1820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/>
              <a:t>Pregnant: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042312" y="6855527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yes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2579186" y="6855527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no</a:t>
            </a:r>
            <a:endParaRPr lang="en-US" sz="100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2135654" y="6867333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643952" y="6867334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560160" y="6656822"/>
            <a:ext cx="722339" cy="1820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Immunization: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512478" y="6656822"/>
            <a:ext cx="554476" cy="182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mock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5327817" y="6656821"/>
            <a:ext cx="1053506" cy="182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2x Inflexal</a:t>
            </a:r>
            <a:endParaRPr lang="en-US" sz="1000" dirty="0"/>
          </a:p>
        </p:txBody>
      </p:sp>
      <p:cxnSp>
        <p:nvCxnSpPr>
          <p:cNvPr id="45" name="Straight Connector 44"/>
          <p:cNvCxnSpPr/>
          <p:nvPr/>
        </p:nvCxnSpPr>
        <p:spPr>
          <a:xfrm>
            <a:off x="4346134" y="6656821"/>
            <a:ext cx="887064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5407926" y="6656822"/>
            <a:ext cx="887064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4249979" y="6849820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yes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4786853" y="6849820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no</a:t>
            </a:r>
            <a:endParaRPr lang="en-US" sz="1000" dirty="0"/>
          </a:p>
        </p:txBody>
      </p:sp>
      <p:cxnSp>
        <p:nvCxnSpPr>
          <p:cNvPr id="49" name="Straight Connector 48"/>
          <p:cNvCxnSpPr/>
          <p:nvPr/>
        </p:nvCxnSpPr>
        <p:spPr>
          <a:xfrm>
            <a:off x="4343320" y="6861625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4851619" y="6861626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3716496" y="6860075"/>
            <a:ext cx="533484" cy="1820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/>
              <a:t>Pregnant: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5311829" y="6861624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yes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>
            <a:off x="5848702" y="6861624"/>
            <a:ext cx="554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no</a:t>
            </a:r>
            <a:endParaRPr lang="en-US" sz="1000" dirty="0"/>
          </a:p>
        </p:txBody>
      </p:sp>
      <p:cxnSp>
        <p:nvCxnSpPr>
          <p:cNvPr id="54" name="Straight Connector 53"/>
          <p:cNvCxnSpPr/>
          <p:nvPr/>
        </p:nvCxnSpPr>
        <p:spPr>
          <a:xfrm>
            <a:off x="5405170" y="6873430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5913469" y="6873430"/>
            <a:ext cx="390947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56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1745372" y="4862317"/>
            <a:ext cx="296940" cy="314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7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5048237" y="4868413"/>
            <a:ext cx="296940" cy="314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5196707" y="4868412"/>
            <a:ext cx="296940" cy="314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Picture 58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1893842" y="7933588"/>
            <a:ext cx="296940" cy="314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2" name="Rectangle 61"/>
          <p:cNvSpPr/>
          <p:nvPr/>
        </p:nvSpPr>
        <p:spPr>
          <a:xfrm>
            <a:off x="3362909" y="8169663"/>
            <a:ext cx="323444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1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100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munization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thers: </a:t>
            </a:r>
          </a:p>
          <a:p>
            <a:pPr algn="just"/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mologous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1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HA </a:t>
            </a:r>
            <a:r>
              <a:rPr lang="en-US" sz="10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ter do not correlate to litter size</a:t>
            </a:r>
            <a:endParaRPr 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128465" y="4464039"/>
            <a:ext cx="64688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u="sng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body responses to vaccination in pregnant and non-pregnant females</a:t>
            </a:r>
            <a:endParaRPr lang="en-US" sz="1400" u="sng" dirty="0"/>
          </a:p>
        </p:txBody>
      </p:sp>
      <p:sp>
        <p:nvSpPr>
          <p:cNvPr id="61" name="TextBox 60"/>
          <p:cNvSpPr txBox="1"/>
          <p:nvPr/>
        </p:nvSpPr>
        <p:spPr>
          <a:xfrm>
            <a:off x="2442154" y="5169024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*</a:t>
            </a:r>
            <a:endParaRPr lang="en-US" sz="1100" dirty="0"/>
          </a:p>
        </p:txBody>
      </p:sp>
      <p:sp>
        <p:nvSpPr>
          <p:cNvPr id="64" name="Right Bracket 63"/>
          <p:cNvSpPr/>
          <p:nvPr/>
        </p:nvSpPr>
        <p:spPr>
          <a:xfrm rot="16200000">
            <a:off x="2522348" y="5145499"/>
            <a:ext cx="72000" cy="50400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8177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19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453" y="1504236"/>
            <a:ext cx="6350000" cy="4022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128464" y="159023"/>
            <a:ext cx="6612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+mj-lt"/>
              </a:rPr>
              <a:t>Supplementary figure 3</a:t>
            </a:r>
          </a:p>
        </p:txBody>
      </p:sp>
      <p:sp>
        <p:nvSpPr>
          <p:cNvPr id="5" name="Rectangle 4"/>
          <p:cNvSpPr/>
          <p:nvPr/>
        </p:nvSpPr>
        <p:spPr>
          <a:xfrm>
            <a:off x="920552" y="416496"/>
            <a:ext cx="50287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u="sng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in bodyweight and clinical scores figures 1C and 3B</a:t>
            </a:r>
            <a:endParaRPr lang="en-US" sz="1400" dirty="0">
              <a:cs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28464" y="6079810"/>
            <a:ext cx="6612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+mj-lt"/>
              </a:rPr>
              <a:t>Supplementary figure 4</a:t>
            </a:r>
          </a:p>
        </p:txBody>
      </p:sp>
      <p:sp>
        <p:nvSpPr>
          <p:cNvPr id="63" name="Rectangle 62"/>
          <p:cNvSpPr/>
          <p:nvPr/>
        </p:nvSpPr>
        <p:spPr>
          <a:xfrm>
            <a:off x="128465" y="6338245"/>
            <a:ext cx="64688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u="sng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in bodyweight and clinical scores figure 3A</a:t>
            </a:r>
            <a:endParaRPr lang="en-US" sz="1400" u="sng" dirty="0"/>
          </a:p>
        </p:txBody>
      </p:sp>
      <p:pic>
        <p:nvPicPr>
          <p:cNvPr id="67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116632" y="2300328"/>
            <a:ext cx="279861" cy="308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116632" y="4381730"/>
            <a:ext cx="279861" cy="308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223682" y="4381730"/>
            <a:ext cx="279861" cy="308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75" name="Group 74"/>
          <p:cNvGrpSpPr/>
          <p:nvPr/>
        </p:nvGrpSpPr>
        <p:grpSpPr>
          <a:xfrm>
            <a:off x="1988840" y="888022"/>
            <a:ext cx="3024336" cy="522518"/>
            <a:chOff x="3920903" y="16485"/>
            <a:chExt cx="6279064" cy="947105"/>
          </a:xfrm>
        </p:grpSpPr>
        <p:grpSp>
          <p:nvGrpSpPr>
            <p:cNvPr id="76" name="Group 68"/>
            <p:cNvGrpSpPr>
              <a:grpSpLocks/>
            </p:cNvGrpSpPr>
            <p:nvPr/>
          </p:nvGrpSpPr>
          <p:grpSpPr bwMode="auto">
            <a:xfrm>
              <a:off x="3920903" y="315890"/>
              <a:ext cx="1363662" cy="647700"/>
              <a:chOff x="4504699" y="3349375"/>
              <a:chExt cx="1521549" cy="727697"/>
            </a:xfrm>
          </p:grpSpPr>
          <p:pic>
            <p:nvPicPr>
              <p:cNvPr id="87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04699" y="3349375"/>
                <a:ext cx="1521549" cy="7276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8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47" t="13968" r="5190" b="14981"/>
              <a:stretch>
                <a:fillRect/>
              </a:stretch>
            </p:blipFill>
            <p:spPr bwMode="auto">
              <a:xfrm>
                <a:off x="5148064" y="3667595"/>
                <a:ext cx="400050" cy="2024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9" name="Oval 88"/>
              <p:cNvSpPr/>
              <p:nvPr/>
            </p:nvSpPr>
            <p:spPr>
              <a:xfrm rot="524470">
                <a:off x="5147682" y="3670418"/>
                <a:ext cx="423342" cy="228297"/>
              </a:xfrm>
              <a:prstGeom prst="ellipse">
                <a:avLst/>
              </a:prstGeom>
              <a:solidFill>
                <a:srgbClr val="00B050">
                  <a:alpha val="4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/>
              </a:p>
            </p:txBody>
          </p:sp>
        </p:grpSp>
        <p:cxnSp>
          <p:nvCxnSpPr>
            <p:cNvPr id="77" name="Straight Connector 76"/>
            <p:cNvCxnSpPr/>
            <p:nvPr/>
          </p:nvCxnSpPr>
          <p:spPr>
            <a:xfrm>
              <a:off x="5284565" y="687038"/>
              <a:ext cx="704850" cy="11113"/>
            </a:xfrm>
            <a:prstGeom prst="line">
              <a:avLst/>
            </a:prstGeom>
            <a:ln>
              <a:solidFill>
                <a:srgbClr val="00B050"/>
              </a:solidFill>
              <a:prstDash val="sysDash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V="1">
              <a:off x="6441183" y="680688"/>
              <a:ext cx="1728000" cy="4763"/>
            </a:xfrm>
            <a:prstGeom prst="line">
              <a:avLst/>
            </a:prstGeom>
            <a:ln>
              <a:solidFill>
                <a:srgbClr val="00B050"/>
              </a:solidFill>
              <a:prstDash val="solid"/>
              <a:tailEnd type="diamon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>
              <a:off x="7374861" y="335892"/>
              <a:ext cx="0" cy="288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Group 79"/>
            <p:cNvGrpSpPr/>
            <p:nvPr/>
          </p:nvGrpSpPr>
          <p:grpSpPr>
            <a:xfrm>
              <a:off x="5989762" y="553307"/>
              <a:ext cx="379413" cy="206375"/>
              <a:chOff x="4154016" y="2931301"/>
              <a:chExt cx="379413" cy="206375"/>
            </a:xfrm>
          </p:grpSpPr>
          <p:pic>
            <p:nvPicPr>
              <p:cNvPr id="85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47" t="13968" r="5190" b="14981"/>
              <a:stretch>
                <a:fillRect/>
              </a:stretch>
            </p:blipFill>
            <p:spPr bwMode="auto">
              <a:xfrm>
                <a:off x="4154016" y="2931301"/>
                <a:ext cx="358775" cy="179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6" name="Oval 85"/>
              <p:cNvSpPr/>
              <p:nvPr/>
            </p:nvSpPr>
            <p:spPr>
              <a:xfrm rot="524470">
                <a:off x="4154016" y="2934476"/>
                <a:ext cx="379413" cy="203200"/>
              </a:xfrm>
              <a:prstGeom prst="ellipse">
                <a:avLst/>
              </a:prstGeom>
              <a:solidFill>
                <a:srgbClr val="00B050">
                  <a:alpha val="4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/>
              </a:p>
            </p:txBody>
          </p:sp>
        </p:grpSp>
        <p:pic>
          <p:nvPicPr>
            <p:cNvPr id="81" name="Picture 6" descr="http://www.health.state.mn.us/divs/idepc/dtopics/stds/images/syringe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0" b="98174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478"/>
            <a:stretch>
              <a:fillRect/>
            </a:stretch>
          </p:blipFill>
          <p:spPr bwMode="auto">
            <a:xfrm>
              <a:off x="5707623" y="188400"/>
              <a:ext cx="385626" cy="4250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2" name="Picture 4" descr="http://plzcdn.com/ZillaIMG/10e854878748a8f3e0e5d86b8cad69c9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duotone>
                <a:schemeClr val="accent1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ackgroundRemoval t="57430" b="86747" l="28857" r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91" t="54312" r="47219" b="10638"/>
            <a:stretch/>
          </p:blipFill>
          <p:spPr bwMode="auto">
            <a:xfrm>
              <a:off x="7233271" y="199051"/>
              <a:ext cx="288000" cy="2549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3" name="TextBox 82"/>
            <p:cNvSpPr txBox="1"/>
            <p:nvPr/>
          </p:nvSpPr>
          <p:spPr>
            <a:xfrm>
              <a:off x="7489468" y="16485"/>
              <a:ext cx="2710499" cy="597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Homologous</a:t>
              </a:r>
            </a:p>
            <a:p>
              <a:r>
                <a:rPr lang="en-US" sz="1000" dirty="0" smtClean="0"/>
                <a:t>H1N1 A/Netherlands/602/09</a:t>
              </a:r>
              <a:endParaRPr lang="en-US" sz="1000" dirty="0"/>
            </a:p>
          </p:txBody>
        </p:sp>
        <p:pic>
          <p:nvPicPr>
            <p:cNvPr id="84" name="Picture 6" descr="http://www.health.state.mn.us/divs/idepc/dtopics/stds/images/syringe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0" b="98174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478"/>
            <a:stretch>
              <a:fillRect/>
            </a:stretch>
          </p:blipFill>
          <p:spPr bwMode="auto">
            <a:xfrm>
              <a:off x="3992911" y="183885"/>
              <a:ext cx="385626" cy="4250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90" name="Straight Connector 89"/>
          <p:cNvCxnSpPr/>
          <p:nvPr/>
        </p:nvCxnSpPr>
        <p:spPr>
          <a:xfrm flipV="1">
            <a:off x="2633740" y="7338762"/>
            <a:ext cx="1728000" cy="4763"/>
          </a:xfrm>
          <a:prstGeom prst="line">
            <a:avLst/>
          </a:prstGeom>
          <a:ln>
            <a:solidFill>
              <a:srgbClr val="00B050"/>
            </a:solidFill>
            <a:prstDash val="solid"/>
            <a:tailEnd type="diamond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>
            <a:off x="3567418" y="7041264"/>
            <a:ext cx="0" cy="288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2" name="Group 91"/>
          <p:cNvGrpSpPr/>
          <p:nvPr/>
        </p:nvGrpSpPr>
        <p:grpSpPr>
          <a:xfrm>
            <a:off x="2182319" y="7258679"/>
            <a:ext cx="379413" cy="206375"/>
            <a:chOff x="4154016" y="2931301"/>
            <a:chExt cx="379413" cy="206375"/>
          </a:xfrm>
        </p:grpSpPr>
        <p:pic>
          <p:nvPicPr>
            <p:cNvPr id="93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47" t="13968" r="5190" b="14981"/>
            <a:stretch>
              <a:fillRect/>
            </a:stretch>
          </p:blipFill>
          <p:spPr bwMode="auto">
            <a:xfrm>
              <a:off x="4154016" y="2931301"/>
              <a:ext cx="358775" cy="179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Oval 93"/>
            <p:cNvSpPr/>
            <p:nvPr/>
          </p:nvSpPr>
          <p:spPr>
            <a:xfrm rot="524470">
              <a:off x="4154016" y="2934476"/>
              <a:ext cx="379413" cy="203200"/>
            </a:xfrm>
            <a:prstGeom prst="ellipse">
              <a:avLst/>
            </a:prstGeom>
            <a:solidFill>
              <a:srgbClr val="00B050">
                <a:alpha val="42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000"/>
            </a:p>
          </p:txBody>
        </p:sp>
      </p:grpSp>
      <p:pic>
        <p:nvPicPr>
          <p:cNvPr id="95" name="Picture 6" descr="http://www.health.state.mn.us/divs/idepc/dtopics/stds/images/syringe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0" b="98174" l="0" r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4478"/>
          <a:stretch>
            <a:fillRect/>
          </a:stretch>
        </p:blipFill>
        <p:spPr bwMode="auto">
          <a:xfrm>
            <a:off x="1900180" y="6893772"/>
            <a:ext cx="385626" cy="4250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6" name="TextBox 95"/>
          <p:cNvSpPr txBox="1"/>
          <p:nvPr/>
        </p:nvSpPr>
        <p:spPr>
          <a:xfrm>
            <a:off x="2044800" y="744308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3 w old</a:t>
            </a:r>
            <a:endParaRPr lang="nl-NL" sz="1000" dirty="0"/>
          </a:p>
        </p:txBody>
      </p:sp>
      <p:sp>
        <p:nvSpPr>
          <p:cNvPr id="97" name="TextBox 96"/>
          <p:cNvSpPr txBox="1"/>
          <p:nvPr/>
        </p:nvSpPr>
        <p:spPr>
          <a:xfrm>
            <a:off x="3288340" y="744308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/>
              <a:t>7 w old</a:t>
            </a:r>
            <a:endParaRPr lang="nl-NL" sz="1000" dirty="0"/>
          </a:p>
        </p:txBody>
      </p:sp>
      <p:pic>
        <p:nvPicPr>
          <p:cNvPr id="98" name="Picture 4" descr="http://plzcdn.com/ZillaIMG/10e854878748a8f3e0e5d86b8cad69c9.jpg"/>
          <p:cNvPicPr>
            <a:picLocks noChangeAspect="1" noChangeArrowheads="1"/>
          </p:cNvPicPr>
          <p:nvPr/>
        </p:nvPicPr>
        <p:blipFill rotWithShape="1">
          <a:blip r:embed="rId13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ackgroundRemoval t="57430" b="86747" l="28857" r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391" t="54312" r="47219" b="10638"/>
          <a:stretch/>
        </p:blipFill>
        <p:spPr bwMode="auto">
          <a:xfrm>
            <a:off x="3425828" y="6904423"/>
            <a:ext cx="288000" cy="2549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9" name="TextBox 98"/>
          <p:cNvSpPr txBox="1"/>
          <p:nvPr/>
        </p:nvSpPr>
        <p:spPr>
          <a:xfrm>
            <a:off x="3658041" y="6817249"/>
            <a:ext cx="1701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omologous</a:t>
            </a:r>
          </a:p>
          <a:p>
            <a:r>
              <a:rPr lang="en-US" sz="1000" dirty="0" smtClean="0"/>
              <a:t>H1N1 A/Netherlands/602/09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6369757" y="4706945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2871779" y="41932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6376392" y="38434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2919467" y="42860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</a:t>
            </a:r>
            <a:endParaRPr lang="en-US" sz="1200" dirty="0"/>
          </a:p>
        </p:txBody>
      </p:sp>
      <p:sp>
        <p:nvSpPr>
          <p:cNvPr id="7" name="Rectangle 6"/>
          <p:cNvSpPr/>
          <p:nvPr/>
        </p:nvSpPr>
        <p:spPr>
          <a:xfrm>
            <a:off x="68740" y="5457056"/>
            <a:ext cx="678926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ct val="20000"/>
              </a:spcBef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 of improvement in change in percentage bodyweight and clinical score compared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the mock immunized group: *p&lt;0.05, *p&lt;0.01, ***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. Last bodyweight observation prior to death carried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. Error bars in the bodyweight graphs depicts the 95% CI, in the clinical score graph the IQR.</a:t>
            </a:r>
          </a:p>
          <a:p>
            <a:pPr algn="just">
              <a:spcBef>
                <a:spcPct val="20000"/>
              </a:spcBef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432070" y="216182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</a:t>
            </a:r>
            <a:endParaRPr lang="en-US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6468992" y="4901877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128465" y="9467517"/>
            <a:ext cx="665679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ct val="20000"/>
              </a:spcBef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t bodyweight observation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or to death carried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rror bars in the bodyweight graphs depicts the 95% CI, in the clinical score graph the IQR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Picture 201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800" y="7897777"/>
            <a:ext cx="6226175" cy="1671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67663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9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9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9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9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9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6" grpId="0"/>
      <p:bldP spid="97" grpId="0"/>
      <p:bldP spid="99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6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896" y="1715473"/>
            <a:ext cx="6464300" cy="1804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128464" y="159023"/>
            <a:ext cx="661290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b="1" dirty="0" smtClean="0">
                <a:latin typeface="+mj-lt"/>
              </a:rPr>
              <a:t>Supplementary figure 5</a:t>
            </a:r>
          </a:p>
        </p:txBody>
      </p:sp>
      <p:sp>
        <p:nvSpPr>
          <p:cNvPr id="5" name="Rectangle 4"/>
          <p:cNvSpPr/>
          <p:nvPr/>
        </p:nvSpPr>
        <p:spPr>
          <a:xfrm>
            <a:off x="920552" y="454596"/>
            <a:ext cx="502872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1400" u="sng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in bodyweight and clinical scores figures 4B</a:t>
            </a:r>
            <a:endParaRPr lang="en-US" sz="1400" dirty="0">
              <a:cs typeface="Times New Roman" panose="02020603050405020304" pitchFamily="18" charset="0"/>
            </a:endParaRPr>
          </a:p>
        </p:txBody>
      </p:sp>
      <p:grpSp>
        <p:nvGrpSpPr>
          <p:cNvPr id="75" name="Group 74"/>
          <p:cNvGrpSpPr/>
          <p:nvPr/>
        </p:nvGrpSpPr>
        <p:grpSpPr>
          <a:xfrm>
            <a:off x="1988840" y="926122"/>
            <a:ext cx="3024336" cy="522518"/>
            <a:chOff x="3920903" y="16485"/>
            <a:chExt cx="6279064" cy="947105"/>
          </a:xfrm>
        </p:grpSpPr>
        <p:grpSp>
          <p:nvGrpSpPr>
            <p:cNvPr id="76" name="Group 68"/>
            <p:cNvGrpSpPr>
              <a:grpSpLocks/>
            </p:cNvGrpSpPr>
            <p:nvPr/>
          </p:nvGrpSpPr>
          <p:grpSpPr bwMode="auto">
            <a:xfrm>
              <a:off x="3920903" y="315890"/>
              <a:ext cx="1363662" cy="647700"/>
              <a:chOff x="4504699" y="3349375"/>
              <a:chExt cx="1521549" cy="727697"/>
            </a:xfrm>
          </p:grpSpPr>
          <p:pic>
            <p:nvPicPr>
              <p:cNvPr id="87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04699" y="3349375"/>
                <a:ext cx="1521549" cy="7276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8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47" t="13968" r="5190" b="14981"/>
              <a:stretch>
                <a:fillRect/>
              </a:stretch>
            </p:blipFill>
            <p:spPr bwMode="auto">
              <a:xfrm>
                <a:off x="5148064" y="3667595"/>
                <a:ext cx="400050" cy="2024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9" name="Oval 88"/>
              <p:cNvSpPr/>
              <p:nvPr/>
            </p:nvSpPr>
            <p:spPr>
              <a:xfrm rot="524470">
                <a:off x="5147682" y="3670418"/>
                <a:ext cx="423342" cy="228297"/>
              </a:xfrm>
              <a:prstGeom prst="ellipse">
                <a:avLst/>
              </a:prstGeom>
              <a:solidFill>
                <a:srgbClr val="00B050">
                  <a:alpha val="4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/>
              </a:p>
            </p:txBody>
          </p:sp>
        </p:grpSp>
        <p:cxnSp>
          <p:nvCxnSpPr>
            <p:cNvPr id="77" name="Straight Connector 76"/>
            <p:cNvCxnSpPr/>
            <p:nvPr/>
          </p:nvCxnSpPr>
          <p:spPr>
            <a:xfrm>
              <a:off x="5284565" y="687038"/>
              <a:ext cx="704850" cy="11113"/>
            </a:xfrm>
            <a:prstGeom prst="line">
              <a:avLst/>
            </a:prstGeom>
            <a:ln>
              <a:solidFill>
                <a:srgbClr val="00B050"/>
              </a:solidFill>
              <a:prstDash val="sysDash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V="1">
              <a:off x="6441183" y="680688"/>
              <a:ext cx="1728000" cy="4763"/>
            </a:xfrm>
            <a:prstGeom prst="line">
              <a:avLst/>
            </a:prstGeom>
            <a:ln>
              <a:solidFill>
                <a:srgbClr val="00B050"/>
              </a:solidFill>
              <a:prstDash val="solid"/>
              <a:tailEnd type="diamond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>
              <a:off x="7374861" y="335892"/>
              <a:ext cx="0" cy="28800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" name="Group 79"/>
            <p:cNvGrpSpPr/>
            <p:nvPr/>
          </p:nvGrpSpPr>
          <p:grpSpPr>
            <a:xfrm>
              <a:off x="5989762" y="553307"/>
              <a:ext cx="379413" cy="206375"/>
              <a:chOff x="4154016" y="2931301"/>
              <a:chExt cx="379413" cy="206375"/>
            </a:xfrm>
          </p:grpSpPr>
          <p:pic>
            <p:nvPicPr>
              <p:cNvPr id="85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647" t="13968" r="5190" b="14981"/>
              <a:stretch>
                <a:fillRect/>
              </a:stretch>
            </p:blipFill>
            <p:spPr bwMode="auto">
              <a:xfrm>
                <a:off x="4154016" y="2931301"/>
                <a:ext cx="358775" cy="179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6" name="Oval 85"/>
              <p:cNvSpPr/>
              <p:nvPr/>
            </p:nvSpPr>
            <p:spPr>
              <a:xfrm rot="524470">
                <a:off x="4154016" y="2934476"/>
                <a:ext cx="379413" cy="203200"/>
              </a:xfrm>
              <a:prstGeom prst="ellipse">
                <a:avLst/>
              </a:prstGeom>
              <a:solidFill>
                <a:srgbClr val="00B050">
                  <a:alpha val="4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/>
              </a:p>
            </p:txBody>
          </p:sp>
        </p:grpSp>
        <p:pic>
          <p:nvPicPr>
            <p:cNvPr id="81" name="Picture 6" descr="http://www.health.state.mn.us/divs/idepc/dtopics/stds/images/syringe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0" b="98174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478"/>
            <a:stretch>
              <a:fillRect/>
            </a:stretch>
          </p:blipFill>
          <p:spPr bwMode="auto">
            <a:xfrm>
              <a:off x="5707623" y="188400"/>
              <a:ext cx="385626" cy="4250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2" name="Picture 4" descr="http://plzcdn.com/ZillaIMG/10e854878748a8f3e0e5d86b8cad69c9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duotone>
                <a:schemeClr val="accent1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57430" b="86747" l="28857" r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91" t="54312" r="47219" b="10638"/>
            <a:stretch/>
          </p:blipFill>
          <p:spPr bwMode="auto">
            <a:xfrm>
              <a:off x="7233271" y="199051"/>
              <a:ext cx="288000" cy="2549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3" name="TextBox 82"/>
            <p:cNvSpPr txBox="1"/>
            <p:nvPr/>
          </p:nvSpPr>
          <p:spPr>
            <a:xfrm>
              <a:off x="7489468" y="16485"/>
              <a:ext cx="2710499" cy="597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Homologous</a:t>
              </a:r>
            </a:p>
            <a:p>
              <a:r>
                <a:rPr lang="en-US" sz="1000" dirty="0" smtClean="0"/>
                <a:t>H1N1 A/Netherlands/602/09</a:t>
              </a:r>
              <a:endParaRPr lang="en-US" sz="1000" dirty="0"/>
            </a:p>
          </p:txBody>
        </p:sp>
        <p:pic>
          <p:nvPicPr>
            <p:cNvPr id="84" name="Picture 6" descr="http://www.health.state.mn.us/divs/idepc/dtopics/stds/images/syringe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0" b="98174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478"/>
            <a:stretch>
              <a:fillRect/>
            </a:stretch>
          </p:blipFill>
          <p:spPr bwMode="auto">
            <a:xfrm>
              <a:off x="3992911" y="183885"/>
              <a:ext cx="385626" cy="4250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4" name="Rectangle 23"/>
          <p:cNvSpPr/>
          <p:nvPr/>
        </p:nvSpPr>
        <p:spPr>
          <a:xfrm>
            <a:off x="68740" y="3472770"/>
            <a:ext cx="678926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ct val="20000"/>
              </a:spcBef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 of improvement in change in percentage bodyweight and clinical score compared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the mock immunized group: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. Last bodyweight 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servation prior to death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ried forward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in the bodyweight graphs depicts the 95% CI, in the clinical score graph the IQR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075310" y="2157879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3075310" y="2297579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6442501" y="2396857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6442501" y="2535356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6442501" y="2692905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6442501" y="2808832"/>
            <a:ext cx="41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***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68736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7</TotalTime>
  <Words>354</Words>
  <Application>Microsoft Office PowerPoint</Application>
  <PresentationFormat>A4 Paper (210x297 mm)</PresentationFormat>
  <Paragraphs>5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Johnson &amp; John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 van der Lubbe</dc:creator>
  <cp:lastModifiedBy>van der Lubbe, Joan [JRDNL]</cp:lastModifiedBy>
  <cp:revision>45</cp:revision>
  <cp:lastPrinted>2016-03-15T14:04:50Z</cp:lastPrinted>
  <dcterms:created xsi:type="dcterms:W3CDTF">2016-03-15T10:56:37Z</dcterms:created>
  <dcterms:modified xsi:type="dcterms:W3CDTF">2016-07-15T11:44:23Z</dcterms:modified>
</cp:coreProperties>
</file>